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119813" cy="61198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14320" y="685440"/>
            <a:ext cx="3429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37"/>
              </a:spcBef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fld id="{5B684701-084C-46D2-977D-2739B340D7E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ldImg"/>
          </p:nvPr>
        </p:nvSpPr>
        <p:spPr>
          <a:xfrm>
            <a:off x="1714680" y="685800"/>
            <a:ext cx="3429000" cy="3429000"/>
          </a:xfrm>
          <a:prstGeom prst="rect">
            <a:avLst/>
          </a:prstGeom>
          <a:ln w="0">
            <a:noFill/>
          </a:ln>
        </p:spPr>
      </p:sp>
      <p:sp>
        <p:nvSpPr>
          <p:cNvPr id="9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37"/>
              </a:spcBef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ja-JP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fld id="{96ED9D47-5202-4722-89FA-E40B320EA79C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31420-1244-4CA6-B213-802EE4844B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5508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360" y="3539160"/>
            <a:ext cx="5508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EADD1-11FA-49DA-96D5-392C5E77E2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9120" y="142884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360" y="353916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9120" y="353916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4CE67-A500-48F5-A79C-703DE07437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1773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9000" y="1428840"/>
            <a:ext cx="1773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2000" y="1428840"/>
            <a:ext cx="1773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360" y="3539160"/>
            <a:ext cx="1773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9000" y="3539160"/>
            <a:ext cx="1773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2000" y="3539160"/>
            <a:ext cx="1773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E54FA-C37E-4579-BA1A-7311A864A5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360" y="1428840"/>
            <a:ext cx="5508720" cy="4039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2643F-2EC5-41DA-87E0-561E9C4019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5508720" cy="40399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B9E16-2120-4245-B47B-BDBF025ADB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2688120" cy="40399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9120" y="1428840"/>
            <a:ext cx="2688120" cy="40399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31001-133D-4891-861C-136A363920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F9685-BBA9-4783-8912-17A956CB33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360" y="244440"/>
            <a:ext cx="5508720" cy="473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8A7A1-6F93-45E8-AA9F-DAB2DF505B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9120" y="1428840"/>
            <a:ext cx="2688120" cy="40399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360" y="353916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8AAC2-2ED5-431A-A368-198A6D6D04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2688120" cy="40399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9120" y="142884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9120" y="353916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DFAD6-7E6F-4F20-BA4A-BC6E8B445F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360" y="142884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9120" y="1428840"/>
            <a:ext cx="26881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360" y="3539160"/>
            <a:ext cx="5508720" cy="19267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21F2B-7E44-44EE-89F6-6348EE3341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360" y="244440"/>
            <a:ext cx="5508720" cy="102096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 algn="ctr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360" y="1428840"/>
            <a:ext cx="5508720" cy="403992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t">
            <a:normAutofit/>
          </a:bodyPr>
          <a:p>
            <a:pPr marL="262080" indent="-262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1" marL="568440" indent="-2174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2" marL="873000" indent="-17460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3" marL="1224000" indent="-17460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4" marL="1573200" indent="-17460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5" marL="1573200" indent="-17460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  <a:p>
            <a:pPr lvl="6" marL="1573200" indent="-17460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000" y="5673600"/>
            <a:ext cx="1428840" cy="32544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5673600"/>
            <a:ext cx="1939680" cy="32544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p>
            <a:pPr indent="0"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5880" y="5673600"/>
            <a:ext cx="1428840" cy="325440"/>
          </a:xfrm>
          <a:prstGeom prst="rect">
            <a:avLst/>
          </a:prstGeom>
          <a:noFill/>
          <a:ln w="0">
            <a:noFill/>
          </a:ln>
        </p:spPr>
        <p:txBody>
          <a:bodyPr lIns="69840" rIns="69840" tIns="34920" bIns="34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fld id="{EB91F6F9-5DC4-4310-A6B0-4258B1D1E8A0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51"/>
          <p:cNvGrpSpPr/>
          <p:nvPr/>
        </p:nvGrpSpPr>
        <p:grpSpPr>
          <a:xfrm>
            <a:off x="278280" y="133200"/>
            <a:ext cx="5758920" cy="5848560"/>
            <a:chOff x="278280" y="133200"/>
            <a:chExt cx="5758920" cy="5848560"/>
          </a:xfrm>
        </p:grpSpPr>
        <p:pic>
          <p:nvPicPr>
            <p:cNvPr id="49" name="Picture 3" descr=""/>
            <p:cNvPicPr/>
            <p:nvPr/>
          </p:nvPicPr>
          <p:blipFill>
            <a:blip r:embed="rId1"/>
            <a:stretch/>
          </p:blipFill>
          <p:spPr>
            <a:xfrm>
              <a:off x="818280" y="133200"/>
              <a:ext cx="5218920" cy="584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円/楕円 53"/>
            <p:cNvSpPr/>
            <p:nvPr/>
          </p:nvSpPr>
          <p:spPr>
            <a:xfrm>
              <a:off x="3841920" y="1645920"/>
              <a:ext cx="7272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円/楕円 54"/>
            <p:cNvSpPr/>
            <p:nvPr/>
          </p:nvSpPr>
          <p:spPr>
            <a:xfrm>
              <a:off x="3841920" y="1933560"/>
              <a:ext cx="7272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円/楕円 55"/>
            <p:cNvSpPr/>
            <p:nvPr/>
          </p:nvSpPr>
          <p:spPr>
            <a:xfrm>
              <a:off x="3841920" y="2149200"/>
              <a:ext cx="7272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円/楕円 56"/>
            <p:cNvSpPr/>
            <p:nvPr/>
          </p:nvSpPr>
          <p:spPr>
            <a:xfrm>
              <a:off x="3338640" y="2436840"/>
              <a:ext cx="7128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円/楕円 57"/>
            <p:cNvSpPr/>
            <p:nvPr/>
          </p:nvSpPr>
          <p:spPr>
            <a:xfrm>
              <a:off x="3770280" y="2484360"/>
              <a:ext cx="7128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円/楕円 58"/>
            <p:cNvSpPr/>
            <p:nvPr/>
          </p:nvSpPr>
          <p:spPr>
            <a:xfrm>
              <a:off x="3233880" y="2870280"/>
              <a:ext cx="7128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円/楕円 59"/>
            <p:cNvSpPr/>
            <p:nvPr/>
          </p:nvSpPr>
          <p:spPr>
            <a:xfrm>
              <a:off x="3446640" y="3327480"/>
              <a:ext cx="7272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円/楕円 60"/>
            <p:cNvSpPr/>
            <p:nvPr/>
          </p:nvSpPr>
          <p:spPr>
            <a:xfrm>
              <a:off x="3392640" y="3236760"/>
              <a:ext cx="7128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円/楕円 61"/>
            <p:cNvSpPr/>
            <p:nvPr/>
          </p:nvSpPr>
          <p:spPr>
            <a:xfrm>
              <a:off x="2617920" y="3373560"/>
              <a:ext cx="7272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円/楕円 62"/>
            <p:cNvSpPr/>
            <p:nvPr/>
          </p:nvSpPr>
          <p:spPr>
            <a:xfrm>
              <a:off x="2690640" y="3733920"/>
              <a:ext cx="7128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円/楕円 63"/>
            <p:cNvSpPr/>
            <p:nvPr/>
          </p:nvSpPr>
          <p:spPr>
            <a:xfrm>
              <a:off x="2227320" y="3805200"/>
              <a:ext cx="7128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円/楕円 64"/>
            <p:cNvSpPr/>
            <p:nvPr/>
          </p:nvSpPr>
          <p:spPr>
            <a:xfrm>
              <a:off x="2123640" y="3427560"/>
              <a:ext cx="7272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円/楕円 65"/>
            <p:cNvSpPr/>
            <p:nvPr/>
          </p:nvSpPr>
          <p:spPr>
            <a:xfrm>
              <a:off x="1353960" y="3892680"/>
              <a:ext cx="7128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円/楕円 66"/>
            <p:cNvSpPr/>
            <p:nvPr/>
          </p:nvSpPr>
          <p:spPr>
            <a:xfrm>
              <a:off x="1496880" y="4310280"/>
              <a:ext cx="7272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円/楕円 67"/>
            <p:cNvSpPr/>
            <p:nvPr/>
          </p:nvSpPr>
          <p:spPr>
            <a:xfrm>
              <a:off x="1322280" y="4886280"/>
              <a:ext cx="71280" cy="7128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テキスト ボックス 68"/>
            <p:cNvSpPr/>
            <p:nvPr/>
          </p:nvSpPr>
          <p:spPr>
            <a:xfrm>
              <a:off x="2907720" y="1326240"/>
              <a:ext cx="849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Ajigasawa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テキスト ボックス 69"/>
            <p:cNvSpPr/>
            <p:nvPr/>
          </p:nvSpPr>
          <p:spPr>
            <a:xfrm>
              <a:off x="4510800" y="1658520"/>
              <a:ext cx="923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Shizukuishi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テキスト ボックス 70"/>
            <p:cNvSpPr/>
            <p:nvPr/>
          </p:nvSpPr>
          <p:spPr>
            <a:xfrm>
              <a:off x="4631040" y="2115000"/>
              <a:ext cx="10065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Yamanouchi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テキスト ボックス 71"/>
            <p:cNvSpPr/>
            <p:nvPr/>
          </p:nvSpPr>
          <p:spPr>
            <a:xfrm>
              <a:off x="4519800" y="2547360"/>
              <a:ext cx="6228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Honna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テキスト ボックス 72"/>
            <p:cNvSpPr/>
            <p:nvPr/>
          </p:nvSpPr>
          <p:spPr>
            <a:xfrm>
              <a:off x="4225320" y="3445560"/>
              <a:ext cx="9626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Shimowada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テキスト ボックス 73"/>
            <p:cNvSpPr/>
            <p:nvPr/>
          </p:nvSpPr>
          <p:spPr>
            <a:xfrm>
              <a:off x="3286440" y="4059720"/>
              <a:ext cx="4215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Fuji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テキスト ボックス 74"/>
            <p:cNvSpPr/>
            <p:nvPr/>
          </p:nvSpPr>
          <p:spPr>
            <a:xfrm>
              <a:off x="2556360" y="4203720"/>
              <a:ext cx="6332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Shingu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テキスト ボックス 75"/>
            <p:cNvSpPr/>
            <p:nvPr/>
          </p:nvSpPr>
          <p:spPr>
            <a:xfrm>
              <a:off x="1842480" y="4419720"/>
              <a:ext cx="653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Yanase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テキスト ボックス 76"/>
            <p:cNvSpPr/>
            <p:nvPr/>
          </p:nvSpPr>
          <p:spPr>
            <a:xfrm>
              <a:off x="1747800" y="2547360"/>
              <a:ext cx="4032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Oki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円/楕円 77"/>
            <p:cNvSpPr/>
            <p:nvPr/>
          </p:nvSpPr>
          <p:spPr>
            <a:xfrm>
              <a:off x="2043000" y="3013200"/>
              <a:ext cx="71280" cy="727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テキスト ボックス 78"/>
            <p:cNvSpPr/>
            <p:nvPr/>
          </p:nvSpPr>
          <p:spPr>
            <a:xfrm>
              <a:off x="2530800" y="2293560"/>
              <a:ext cx="842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Tateyama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テキスト ボックス 79"/>
            <p:cNvSpPr/>
            <p:nvPr/>
          </p:nvSpPr>
          <p:spPr>
            <a:xfrm>
              <a:off x="3059280" y="1933560"/>
              <a:ext cx="5097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Sado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テキスト ボックス 80"/>
            <p:cNvSpPr/>
            <p:nvPr/>
          </p:nvSpPr>
          <p:spPr>
            <a:xfrm>
              <a:off x="949320" y="2907360"/>
              <a:ext cx="7765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Tsuyama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テキスト ボックス 81"/>
            <p:cNvSpPr/>
            <p:nvPr/>
          </p:nvSpPr>
          <p:spPr>
            <a:xfrm>
              <a:off x="278280" y="3517560"/>
              <a:ext cx="4701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YI96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テキスト ボックス 82"/>
            <p:cNvSpPr/>
            <p:nvPr/>
          </p:nvSpPr>
          <p:spPr>
            <a:xfrm>
              <a:off x="370800" y="4347720"/>
              <a:ext cx="4701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YI38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テキスト ボックス 83"/>
            <p:cNvSpPr/>
            <p:nvPr/>
          </p:nvSpPr>
          <p:spPr>
            <a:xfrm>
              <a:off x="367200" y="5029920"/>
              <a:ext cx="7779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98400"/>
                  <a:tab algn="l" pos="1397160"/>
                  <a:tab algn="l" pos="2095560"/>
                  <a:tab algn="l" pos="2793960"/>
                  <a:tab algn="l" pos="3492360"/>
                  <a:tab algn="l" pos="4191120"/>
                  <a:tab algn="l" pos="4889520"/>
                  <a:tab algn="l" pos="5587920"/>
                  <a:tab algn="l" pos="6286680"/>
                  <a:tab algn="l" pos="6985080"/>
                  <a:tab algn="l" pos="7683480"/>
                  <a:tab algn="l" pos="8381880"/>
                  <a:tab algn="l" pos="9080640"/>
                  <a:tab algn="l" pos="9779040"/>
                  <a:tab algn="l" pos="1047744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Calibri"/>
                </a:rPr>
                <a:t>Shiratani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直線コネクタ 84"/>
            <p:cNvSpPr/>
            <p:nvPr/>
          </p:nvSpPr>
          <p:spPr>
            <a:xfrm>
              <a:off x="3586320" y="1541160"/>
              <a:ext cx="255240" cy="139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線コネクタ 85"/>
            <p:cNvSpPr/>
            <p:nvPr/>
          </p:nvSpPr>
          <p:spPr>
            <a:xfrm flipV="1">
              <a:off x="3914640" y="1861560"/>
              <a:ext cx="502920" cy="98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線コネクタ 86"/>
            <p:cNvSpPr/>
            <p:nvPr/>
          </p:nvSpPr>
          <p:spPr>
            <a:xfrm>
              <a:off x="3914640" y="2192040"/>
              <a:ext cx="574560" cy="44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87"/>
            <p:cNvSpPr/>
            <p:nvPr/>
          </p:nvSpPr>
          <p:spPr>
            <a:xfrm flipH="1" flipV="1">
              <a:off x="3306600" y="2214360"/>
              <a:ext cx="72720" cy="242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線コネクタ 88"/>
            <p:cNvSpPr/>
            <p:nvPr/>
          </p:nvSpPr>
          <p:spPr>
            <a:xfrm>
              <a:off x="3780720" y="2484360"/>
              <a:ext cx="649080" cy="187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線コネクタ 89"/>
            <p:cNvSpPr/>
            <p:nvPr/>
          </p:nvSpPr>
          <p:spPr>
            <a:xfrm flipH="1" flipV="1">
              <a:off x="3138120" y="2580840"/>
              <a:ext cx="120600" cy="298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直線コネクタ 90"/>
            <p:cNvSpPr/>
            <p:nvPr/>
          </p:nvSpPr>
          <p:spPr>
            <a:xfrm flipH="1" flipV="1">
              <a:off x="2001960" y="2796840"/>
              <a:ext cx="71280" cy="244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線コネクタ 91"/>
            <p:cNvSpPr/>
            <p:nvPr/>
          </p:nvSpPr>
          <p:spPr>
            <a:xfrm flipH="1" flipV="1">
              <a:off x="1548360" y="3132360"/>
              <a:ext cx="586080" cy="335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線コネクタ 92"/>
            <p:cNvSpPr/>
            <p:nvPr/>
          </p:nvSpPr>
          <p:spPr>
            <a:xfrm flipV="1">
              <a:off x="3425760" y="3294000"/>
              <a:ext cx="0" cy="792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線コネクタ 93"/>
            <p:cNvSpPr/>
            <p:nvPr/>
          </p:nvSpPr>
          <p:spPr>
            <a:xfrm flipH="1" flipV="1">
              <a:off x="3508560" y="3373200"/>
              <a:ext cx="574560" cy="215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線コネクタ 94"/>
            <p:cNvSpPr/>
            <p:nvPr/>
          </p:nvSpPr>
          <p:spPr>
            <a:xfrm flipH="1" flipV="1">
              <a:off x="2733480" y="3782520"/>
              <a:ext cx="36360" cy="431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95"/>
            <p:cNvSpPr/>
            <p:nvPr/>
          </p:nvSpPr>
          <p:spPr>
            <a:xfrm flipV="1">
              <a:off x="2056680" y="3804840"/>
              <a:ext cx="215640" cy="6490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96"/>
            <p:cNvSpPr/>
            <p:nvPr/>
          </p:nvSpPr>
          <p:spPr>
            <a:xfrm flipH="1" flipV="1">
              <a:off x="745920" y="3733920"/>
              <a:ext cx="607680" cy="195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97"/>
            <p:cNvSpPr/>
            <p:nvPr/>
          </p:nvSpPr>
          <p:spPr>
            <a:xfrm flipH="1">
              <a:off x="756360" y="4371120"/>
              <a:ext cx="802800" cy="129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線コネクタ 98"/>
            <p:cNvSpPr/>
            <p:nvPr/>
          </p:nvSpPr>
          <p:spPr>
            <a:xfrm flipV="1">
              <a:off x="985680" y="4929480"/>
              <a:ext cx="360360" cy="180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テキスト ボックス 78"/>
          <p:cNvSpPr/>
          <p:nvPr/>
        </p:nvSpPr>
        <p:spPr>
          <a:xfrm>
            <a:off x="1985760" y="2124000"/>
            <a:ext cx="513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98400"/>
                <a:tab algn="l" pos="1397160"/>
                <a:tab algn="l" pos="2095560"/>
                <a:tab algn="l" pos="2793960"/>
                <a:tab algn="l" pos="3492360"/>
                <a:tab algn="l" pos="4191120"/>
                <a:tab algn="l" pos="4889520"/>
                <a:tab algn="l" pos="5587920"/>
                <a:tab algn="l" pos="6286680"/>
                <a:tab algn="l" pos="6985080"/>
                <a:tab algn="l" pos="7683480"/>
                <a:tab algn="l" pos="8381880"/>
                <a:tab algn="l" pos="9080640"/>
                <a:tab algn="l" pos="9779040"/>
                <a:tab algn="l" pos="104774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Ashu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直線コネクタ 51"/>
          <p:cNvSpPr/>
          <p:nvPr/>
        </p:nvSpPr>
        <p:spPr>
          <a:xfrm flipH="1" flipV="1">
            <a:off x="2241720" y="2417760"/>
            <a:ext cx="387360" cy="966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5T05:56:56Z</dcterms:created>
  <dc:creator>Saneyoshi Ueno</dc:creator>
  <dc:description/>
  <dc:language>en-US</dc:language>
  <cp:lastModifiedBy>森口喜成</cp:lastModifiedBy>
  <dcterms:modified xsi:type="dcterms:W3CDTF">2011-08-31T08:21:46Z</dcterms:modified>
  <cp:revision>4</cp:revision>
  <dc:subject/>
  <dc:title>スライド 1</dc:title>
</cp:coreProperties>
</file>